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6E6EC-6A4A-4A5F-823F-2EA9B20060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52FA1-59EF-4613-8CE2-975FECC7E6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5AF46FF-B027-4B69-B614-549045D3EB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D6D2AC6-FDB6-4D85-9892-8EEC25156D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76DFA97-7647-4598-ACF7-3CDCBEDAD0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8B6E88F-98E7-43E4-A928-A6CEFAD5F3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0FC84C5-6C58-46C3-8DFA-5376A58A17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86BD10B-1DA8-4521-9387-D0DE32055C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8981FA2-C716-49C7-AD50-46135A37FB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105592A-9D43-4259-A841-94CDBB631B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B04AB1A8-FD94-48E3-9882-1A63CA3494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C4A01B2-CC1E-4779-B640-D47580A90F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D059D-7323-4CE6-B6B4-B5BBC97EB5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BE7676D-00A1-4373-AB30-88547BFA6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55CC47B-22E0-4805-A399-56DBCAC21A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FFD6AC4-B39D-49B3-98AB-C134665C48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104163E-C9D6-4704-BD4C-0ECCF51CFA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08EC939-0AD7-4E60-8889-04FC83E50B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98A603A-E6EB-4489-95C1-9433EE8184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23CA8F7-52DF-41D6-9A3A-B368EC17FA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3C32407-2717-43BC-8C1F-7E2E49394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DC16737-0359-4B76-A7B8-920661C749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C0ED5FB-12D5-4E81-B90C-05FAF9FE1D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FA1917-1FA5-4D58-ABE0-69A3FB773D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1B58BAA-09BC-4844-9440-6A3BB9779F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EF34561-43F1-48BB-9F5D-CEE60B2F47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9C27263-F591-445E-A84C-0F04347D4A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186E974-C96B-4FAD-A438-8479CE024D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11F1FB6-4D10-40A0-BEC4-B872228FB8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B9F6256-D06F-41FA-B097-828EC93F02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A0F70F7-AC20-46F6-9829-42C6C250F6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848B3F3-A84E-4F2D-BEF1-8FE5972272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A4AB834-1988-45C1-A4BD-4C590565F6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C16C0B2-6D29-4C86-BFFC-1C63453CF3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1E89976-E188-4B0A-A4CA-C098ECA815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2D1C779-8BA7-4692-B541-B5435C6DC6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8D8F22E-8396-450D-A5F7-A2C416CCAC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857D21E-BF4A-4E81-A386-7987D62449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BFDC662-2B3B-4B84-9489-6AF0040B8B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2DCEDF9-8079-49FE-931E-13C2903B5F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E0F6C90-FC1D-4CC7-AB31-70090066D0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66C4700-BEA0-4247-B41F-AF0AC08867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B9A65E5-072F-401C-84D7-3DD3586503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2DFB67E-363A-499B-9C95-94058FA105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C2B73F8-5D4F-4FDC-B56E-43EBB26DD7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831E1DD-C527-405B-835A-1B892581EA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EA6543C-A3ED-492C-801E-F0FDF98366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6BF1DB5-7D64-4E30-9B01-2250F068CF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E6E2720-810A-4FCA-B7F9-E8C6DDAAB3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2B21200-D907-491F-8C37-6C5800652F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7F60FB1-BCD5-4353-8116-B15203A926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D3B3FE0-29AC-4FF9-AA08-D01D231A37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C100F6-39E3-4222-B875-3A93182BB6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2E67EB-2790-4D89-BD76-50F42F060D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8C4013-6B1F-4CD9-8E5C-609CFBC031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0FA018A-4F43-46EA-8DAF-D77A97543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BEACA-7999-4AA7-8376-032AFCCEC0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3BD34A-6DE8-455C-BEF0-C79420D375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F16316D-C972-4697-838F-6276628469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94DDA9-5BEB-40A0-8B4E-5711284B73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64AAA2-E52A-4D02-83BD-C0A2326142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68ED00A-71FC-41BF-8C36-AFFB83520F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2734058-513B-471B-9EB2-AAD40B8FD4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2F274CF-6E00-43AC-B5CB-42B9891D66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90BA7F7-0907-4B5E-B80B-C453B80685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A17EE8A-FA32-4CA8-9B6A-E7BEF39E3F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E87CCB5-8B6C-4EF1-8EC3-F77E07616A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BC605-986F-4630-BD69-4CF0369946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BD19951-576D-4997-B490-9819E7030C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8B683E9-765A-4FF4-B0C3-F1CC5189C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032E84B-5041-4777-A36F-5A90635B35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0DF7187-29A4-4571-8708-D8E3574233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54FD1CD-6245-4101-A077-80662D9CE9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98C8686-9FE9-41AD-ACF5-DB6D7E0B6C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152E39B-578E-4615-BCA7-6A349CEE7E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A03C90A-8118-448D-9626-9C5AD25BE8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995320D-3CCD-4141-A247-77D84023E7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135A1E6-CC58-4FDF-AE7B-B20C924CE2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67457-34D4-46B9-A2A1-09C8C78370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B2D8867-E7BB-4D70-8149-3517E00981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1C8D79D-AB56-4EE9-9354-C57DEDE660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160459F-A951-4362-8940-D534E7EF2F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D97864E-B642-491E-B759-78C80065D0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F0F4C95-41DF-4648-912F-F52B9CCF13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467A685-8473-4B71-9A58-A4A52618D9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DF883BA-309C-42B6-9E35-AC8C5AA84A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2E4E1B9-1E26-45CA-9D75-A025C395D0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84339E3-9D06-49F2-B481-42D76E1153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2F89965-6976-47EB-80E1-7F09591A93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EA5CB-0DBB-488F-9278-26C8B62C98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CED9A57-2B49-4067-9F81-993405C6C6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48DA774-9127-4CBB-9E3C-1315A4C4E1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2CB79CF-4817-4535-B2A2-63A7D6CA2B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0D9F68F-90E7-43F0-AE40-D849DB959C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5699F8A-DE1E-4795-A681-8FD799F888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429ED6E-0C51-4278-8675-FB2C7D088A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07712EB-060C-4291-A9B3-2F39759D34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F123551-3100-442F-B4CE-B3C67AC7CB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9E1333A-4317-4C24-AB9A-5B86DE83CC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63865EB-AAE5-4662-9F2A-A83CB00243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DBC2B-7CB6-44B9-A1C9-7B3F7CED90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B0EA2DD-1A03-4FD2-9D69-DD7503225E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266FAB8-27BD-45A7-BA83-A4BE0CF045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A80F79E-FFE6-4D39-9BB1-80C90072D9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F16D1D8-6405-45F4-81DE-F6E6D73CF1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0FD40E3-1ADE-4D4E-B49D-58C178A6EC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87081FA-1AC0-4ABF-ABDC-14C725EE00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281B47F-3EBC-4887-BFC2-16B43671CF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874D4CB-1264-444D-8E94-C77280DCFF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9BC01CE-C349-4098-9C8B-E44931FFB4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9AF2AB6-983F-4D75-AF94-C9D2917A05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121FB-0641-4EC5-90CE-1C4EE44A8D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C7F42F3-F252-401F-93D1-BC8C9EDF60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C99929E-A691-43CA-BF09-C0DF204B83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36B4F99-DF30-477C-98C1-C72E22AA31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EA8E291-2C09-4DC4-BD58-D23760F3A5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8F2D3AE-7F11-4C32-A59C-A6137256B0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1F35859-060D-47A1-AC0F-B73EF3F7F9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B8D58D8-ACE5-4E3A-8F82-50C808DB96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72D93D2-7EDB-4460-8DB7-B4FAB2DBA1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60C64E6-0A3B-48DD-BA94-E14E77E3A4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9E6DC71-F1AC-43C1-A034-2A08D699DB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3245F-A37D-444B-BF77-97DE96917E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C853506-4CF6-4739-8D05-B8D4C36F01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78749C8-A552-4C42-8F5B-BF6E8AA403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0B0532E-9527-4FA9-80FE-F54E559EDC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285E56A-C5B9-4DA6-84C6-C01FD1C24D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DF91A8F-796A-423E-AB16-BBFFD86D61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9399EFE-D54D-470A-A9EB-2696A6702E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7EAADCB-72A8-4744-B206-9EC599EF1D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E0D33B6-62C1-4565-B657-4CD904C3F6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2D2EE0B-AC77-4970-8C44-E014DC9770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42E632E-2C6F-4C36-887C-6AB45DCE23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8985D-D66D-4F79-A95B-EFB52339A1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170CDA3-041B-4BA0-BA50-738DF37080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CD7DAB1-2BCA-4C8C-805E-4FA5E48C5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170F922-17EF-4CD3-96F6-60B49CBCB8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B7846D1-D03C-4BDA-A0BF-B9E5A4D75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D7937D7-BE4F-4355-ADF7-72FAD1501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98CB222-8D2D-4CD5-BD59-E2A6F7D395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ECA35DE-E5C5-4A12-A17A-4B87D4E25F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B3438C3-75D9-44B2-982F-85C1F5F67B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73D728B-6ED2-40F4-9368-096464C0CB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D58AB31-50BE-4CA7-85F9-33C3C26043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C690EA-584F-4C5E-A504-C913EF1DD475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CE874A-1136-4954-B499-66FE106B1B9C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EA00CB-F074-4D0E-BD47-739A1C10FF3A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673285-DDE3-4D66-BAF1-CB93B254BE0D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B75C72-D5D9-431A-B267-99F998E459CA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B2DC49-7F6B-483E-98FC-5DCBA9617D24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AB2BE3-8B3B-4458-8B5E-B491857F6097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5397E1-04FC-49A0-B62B-1DB0962FC600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D8DBC6-C025-4628-B076-7828EF6FE223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14B575-84B9-4EBA-9D1A-F1885E1E2A3E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CE160A-7962-4909-BF11-E14736F5E7DB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A7DF73-E603-4BD0-B2F4-DE0DB756A51A}" type="slidenum">
              <a:rPr b="0" lang="zh-CN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2" name="Picture 4" descr="C:\Users\Hongshun\Documents\PCBP1 kd mRNA Decay.tif"/>
          <p:cNvPicPr/>
          <p:nvPr/>
        </p:nvPicPr>
        <p:blipFill>
          <a:blip r:embed="rId1"/>
          <a:srcRect l="2912" t="3175" r="8965" b="3212"/>
          <a:stretch/>
        </p:blipFill>
        <p:spPr>
          <a:xfrm>
            <a:off x="3332160" y="1271520"/>
            <a:ext cx="3333600" cy="2695680"/>
          </a:xfrm>
          <a:prstGeom prst="rect">
            <a:avLst/>
          </a:prstGeom>
          <a:ln w="0">
            <a:noFill/>
          </a:ln>
        </p:spPr>
      </p:pic>
      <p:pic>
        <p:nvPicPr>
          <p:cNvPr id="493" name="Picture 5" descr="C:\Users\Hongshun\Documents\PCBP1 oe mRNA Decay.tif"/>
          <p:cNvPicPr/>
          <p:nvPr/>
        </p:nvPicPr>
        <p:blipFill>
          <a:blip r:embed="rId2"/>
          <a:srcRect l="2770" t="4174" r="10117" b="4874"/>
          <a:stretch/>
        </p:blipFill>
        <p:spPr>
          <a:xfrm>
            <a:off x="69840" y="1306440"/>
            <a:ext cx="3295800" cy="2619360"/>
          </a:xfrm>
          <a:prstGeom prst="rect">
            <a:avLst/>
          </a:prstGeom>
          <a:ln w="0">
            <a:noFill/>
          </a:ln>
        </p:spPr>
      </p:pic>
      <p:sp>
        <p:nvSpPr>
          <p:cNvPr id="494" name="TextBox 3"/>
          <p:cNvSpPr/>
          <p:nvPr/>
        </p:nvSpPr>
        <p:spPr>
          <a:xfrm>
            <a:off x="333360" y="4270320"/>
            <a:ext cx="64087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5.  p27 mRNA stabilized by PCBP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half-life of p27 mRNA was derived from the decay curve plotted from the Fig 5G and H. Linear regression equation in A: PCBP1, y=-0.0096x + 0.998,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0.99; GFP, y=-0.058x + 0.9844,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0.9865; B: PCBP1 KD, y=-0.0749x + 0.965,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0.9607; GFP, y= -0.0749x + 0.9677, R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0.9387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5" name="TextBox 4"/>
          <p:cNvSpPr/>
          <p:nvPr/>
        </p:nvSpPr>
        <p:spPr>
          <a:xfrm>
            <a:off x="1915560" y="38862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6" name="TextBox 9"/>
          <p:cNvSpPr/>
          <p:nvPr/>
        </p:nvSpPr>
        <p:spPr>
          <a:xfrm>
            <a:off x="5084280" y="38862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4:46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